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119813" cy="10080625"/>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3E27805-5C34-42FE-A32D-5AE2284354B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458280" y="2910960"/>
            <a:ext cx="520380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458280" y="6070320"/>
            <a:ext cx="520380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F570762-8DE7-4CA0-A9D1-8C72B195A4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45828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12516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458280" y="607032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125160" y="607032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FE947D4-B7C4-4F07-8CA5-DC73D025D04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458280" y="291096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217960" y="291096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3977640" y="291096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458280" y="607032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217960" y="607032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3977640" y="6070320"/>
            <a:ext cx="1675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F014E3E-BFAA-4562-A3F6-647A2F6DCE9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458280" y="2910960"/>
            <a:ext cx="5203800" cy="6048360"/>
          </a:xfrm>
          <a:prstGeom prst="rect">
            <a:avLst/>
          </a:prstGeom>
          <a:noFill/>
          <a:ln w="0">
            <a:noFill/>
          </a:ln>
        </p:spPr>
        <p:txBody>
          <a:bodyPr lIns="0" rIns="0" tIns="0" bIns="0" anchor="ctr">
            <a:noAutofit/>
          </a:bodyPr>
          <a:p>
            <a:pPr indent="0" algn="ctr" rtl="1">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4049185-CF53-4064-983B-A7537C98613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458280" y="2910960"/>
            <a:ext cx="5203800" cy="60483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561FF2F-A5EE-45D2-8FCF-9887640A6D5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458280" y="2910960"/>
            <a:ext cx="2539440" cy="60483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125160" y="2910960"/>
            <a:ext cx="2539440" cy="60483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B5EF8B6-F75A-423E-B551-54292449CF9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A27405-7627-45FE-8433-29F0B4BE1D0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8280" y="895320"/>
            <a:ext cx="5203800" cy="7794360"/>
          </a:xfrm>
          <a:prstGeom prst="rect">
            <a:avLst/>
          </a:prstGeom>
          <a:noFill/>
          <a:ln w="0">
            <a:noFill/>
          </a:ln>
        </p:spPr>
        <p:txBody>
          <a:bodyPr lIns="0" rIns="0" tIns="0" bIns="0" anchor="ctr">
            <a:noAutofit/>
          </a:bodyPr>
          <a:p>
            <a:pPr algn="ctr" rtl="1">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631D761-794F-4092-AA1B-EC5E5BA8DE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45828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125160" y="2910960"/>
            <a:ext cx="2539440" cy="60483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458280" y="607032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EABBBF-F034-4DB5-9FFE-6D050E6765D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458280" y="2910960"/>
            <a:ext cx="2539440" cy="60483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12516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125160" y="607032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E76FC7-E330-44A8-9186-5CB03289C6F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45828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125160" y="2910960"/>
            <a:ext cx="253944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458280" y="6070320"/>
            <a:ext cx="5203800" cy="288504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6E6F10-1894-44EF-9EAF-FEE448F1FA5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8280" y="895320"/>
            <a:ext cx="5203800" cy="16812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458280" y="2910960"/>
            <a:ext cx="5203800" cy="6048360"/>
          </a:xfrm>
          <a:prstGeom prst="rect">
            <a:avLst/>
          </a:prstGeom>
          <a:noFill/>
          <a:ln w="0">
            <a:noFill/>
          </a:ln>
        </p:spPr>
        <p:txBody>
          <a:bodyPr lIns="90000" rIns="90000" tIns="46800" bIns="46800" anchor="t">
            <a:normAutofit fontScale="95000"/>
          </a:bodyPr>
          <a:p>
            <a:pPr marL="325800" indent="-32580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05600" indent="-27144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085760" indent="-21708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19920" indent="-21708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1954440" indent="-21708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1954440" indent="-21708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1954440" indent="-217080" algn="r" rtl="1">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4400640" y="9185040"/>
            <a:ext cx="1272960" cy="671400"/>
          </a:xfrm>
          <a:prstGeom prst="rect">
            <a:avLst/>
          </a:prstGeom>
          <a:noFill/>
          <a:ln w="0">
            <a:noFill/>
          </a:ln>
        </p:spPr>
        <p:txBody>
          <a:bodyPr lIns="90000" rIns="90000" tIns="46800" bIns="46800" anchor="t">
            <a:noAutofit/>
          </a:bodyPr>
          <a:lstStyle>
            <a:lvl1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400" spc="-1" strike="noStrike">
                <a:solidFill>
                  <a:srgbClr val="000000"/>
                </a:solidFill>
                <a:latin typeface="Times New Roman"/>
              </a:defRPr>
            </a:lvl1pPr>
          </a:lstStyle>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he-IL"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092320" y="9185040"/>
            <a:ext cx="1936800" cy="6714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77720" y="9185040"/>
            <a:ext cx="1276560" cy="671400"/>
          </a:xfrm>
          <a:prstGeom prst="rect">
            <a:avLst/>
          </a:prstGeom>
          <a:noFill/>
          <a:ln w="0">
            <a:noFill/>
          </a:ln>
        </p:spPr>
        <p:txBody>
          <a:bodyPr lIns="90000" rIns="90000" tIns="46800" bIns="46800" anchor="t">
            <a:noAutofit/>
          </a:bodyPr>
          <a:lstStyle>
            <a:lvl1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400" spc="-1" strike="noStrike">
                <a:solidFill>
                  <a:srgbClr val="000000"/>
                </a:solidFill>
                <a:latin typeface="Times New Roman"/>
              </a:defRPr>
            </a:lvl1pPr>
          </a:lstStyle>
          <a:p>
            <a: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425AF28-D63C-4074-BEFD-798DCFA5FBE0}" type="slidenum">
              <a:rPr b="0" lang="he-IL"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744640" y="8475840"/>
            <a:ext cx="15130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GIFtS</a:t>
            </a:r>
            <a:endParaRPr b="0" lang="en-US" sz="1800" spc="-1" strike="noStrike">
              <a:solidFill>
                <a:srgbClr val="000000"/>
              </a:solidFill>
              <a:latin typeface="Times New Roman"/>
            </a:endParaRPr>
          </a:p>
        </p:txBody>
      </p:sp>
      <p:grpSp>
        <p:nvGrpSpPr>
          <p:cNvPr id="42" name=""/>
          <p:cNvGrpSpPr/>
          <p:nvPr/>
        </p:nvGrpSpPr>
        <p:grpSpPr>
          <a:xfrm>
            <a:off x="334800" y="698400"/>
            <a:ext cx="5425920" cy="3933720"/>
            <a:chOff x="334800" y="698400"/>
            <a:chExt cx="5425920" cy="3933720"/>
          </a:xfrm>
        </p:grpSpPr>
        <p:pic>
          <p:nvPicPr>
            <p:cNvPr id="43" name="" descr=""/>
            <p:cNvPicPr/>
            <p:nvPr/>
          </p:nvPicPr>
          <p:blipFill>
            <a:blip r:embed="rId1"/>
            <a:stretch/>
          </p:blipFill>
          <p:spPr>
            <a:xfrm>
              <a:off x="693720" y="698400"/>
              <a:ext cx="5067000" cy="3933720"/>
            </a:xfrm>
            <a:prstGeom prst="rect">
              <a:avLst/>
            </a:prstGeom>
            <a:ln w="0">
              <a:noFill/>
            </a:ln>
          </p:spPr>
        </p:pic>
        <p:sp>
          <p:nvSpPr>
            <p:cNvPr id="44" name=""/>
            <p:cNvSpPr/>
            <p:nvPr/>
          </p:nvSpPr>
          <p:spPr>
            <a:xfrm rot="16200000">
              <a:off x="87120" y="2538000"/>
              <a:ext cx="8636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ount</a:t>
              </a:r>
              <a:endParaRPr b="0" lang="en-US" sz="1800" spc="-1" strike="noStrike">
                <a:solidFill>
                  <a:srgbClr val="000000"/>
                </a:solidFill>
                <a:latin typeface="Times New Roman"/>
              </a:endParaRPr>
            </a:p>
          </p:txBody>
        </p:sp>
      </p:grpSp>
      <p:grpSp>
        <p:nvGrpSpPr>
          <p:cNvPr id="45" name=""/>
          <p:cNvGrpSpPr/>
          <p:nvPr/>
        </p:nvGrpSpPr>
        <p:grpSpPr>
          <a:xfrm>
            <a:off x="431640" y="4622760"/>
            <a:ext cx="5369040" cy="3924360"/>
            <a:chOff x="431640" y="4622760"/>
            <a:chExt cx="5369040" cy="3924360"/>
          </a:xfrm>
        </p:grpSpPr>
        <p:pic>
          <p:nvPicPr>
            <p:cNvPr id="46" name="" descr=""/>
            <p:cNvPicPr/>
            <p:nvPr/>
          </p:nvPicPr>
          <p:blipFill>
            <a:blip r:embed="rId2"/>
            <a:stretch/>
          </p:blipFill>
          <p:spPr>
            <a:xfrm>
              <a:off x="676080" y="4622760"/>
              <a:ext cx="5124600" cy="3924360"/>
            </a:xfrm>
            <a:prstGeom prst="rect">
              <a:avLst/>
            </a:prstGeom>
            <a:ln w="0">
              <a:noFill/>
            </a:ln>
          </p:spPr>
        </p:pic>
        <p:sp>
          <p:nvSpPr>
            <p:cNvPr id="47" name=""/>
            <p:cNvSpPr/>
            <p:nvPr/>
          </p:nvSpPr>
          <p:spPr>
            <a:xfrm rot="16200000">
              <a:off x="183960" y="6208560"/>
              <a:ext cx="8632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ount</a:t>
              </a:r>
              <a:endParaRPr b="0" lang="en-US" sz="1800" spc="-1" strike="noStrike">
                <a:solidFill>
                  <a:srgbClr val="000000"/>
                </a:solidFill>
                <a:latin typeface="Times New Roman"/>
              </a:endParaRPr>
            </a:p>
          </p:txBody>
        </p:sp>
      </p:grpSp>
      <p:sp>
        <p:nvSpPr>
          <p:cNvPr id="48" name=""/>
          <p:cNvSpPr/>
          <p:nvPr/>
        </p:nvSpPr>
        <p:spPr>
          <a:xfrm>
            <a:off x="404640" y="590400"/>
            <a:ext cx="4683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Times New Roman"/>
            </a:endParaRPr>
          </a:p>
        </p:txBody>
      </p:sp>
      <p:sp>
        <p:nvSpPr>
          <p:cNvPr id="49" name=""/>
          <p:cNvSpPr/>
          <p:nvPr/>
        </p:nvSpPr>
        <p:spPr>
          <a:xfrm>
            <a:off x="404640" y="4646520"/>
            <a:ext cx="4683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Times New Roman"/>
            </a:endParaRPr>
          </a:p>
        </p:txBody>
      </p:sp>
      <p:sp>
        <p:nvSpPr>
          <p:cNvPr id="50" name=""/>
          <p:cNvSpPr/>
          <p:nvPr/>
        </p:nvSpPr>
        <p:spPr>
          <a:xfrm>
            <a:off x="612720" y="9001080"/>
            <a:ext cx="529272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S2: Distribution of GIFtS for genes with specific GCI scores</a:t>
            </a:r>
            <a:endParaRPr b="0" lang="en-US" sz="12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GIFtS scores distribution was generated for all 489 genes with GCI score of exactly 10.0 (A) as well as for all 1961 genes with GCI score of exactly 2.2 (B) (the relevant genes may be obtained from: [43]).</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Weizmann Institute of Science</cp:lastModifiedBy>
  <dcterms:modified xsi:type="dcterms:W3CDTF">2009-10-18T10:11:59Z</dcterms:modified>
  <cp:revision>10</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LCID">
    <vt:r8>1037</vt:r8>
  </property>
  <property fmtid="{D5CDD505-2E9C-101B-9397-08002B2CF9AE}" pid="3" name="Version">
    <vt:r8>1</vt:r8>
  </property>
</Properties>
</file>